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A2A16B-B223-4B40-BA1F-95C2CD6431B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588C4D-CAC5-4729-B8B5-DB72B72BB6A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783DB2-6177-4629-8114-F6B1EFFEC6F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4A415E-7105-4A21-8AEE-0C746CA480A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6D448F-2345-4AE2-90F5-18E8241C6C2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96D234-FB86-420C-8E4E-E8C4F845EED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24451F-3744-47CB-94C7-1F97C26CDFE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F5E6A0-6914-4317-9716-55B860493A6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801010-6614-4FDD-884F-68BFBCF7A31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FDD90F-0CB7-4E5B-85D9-500C0CC439D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95FF03-353D-429A-A57F-DCD9283AC30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B49BD8-4480-4D6E-9136-B87F021275A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85BC47D-3BC9-4DF9-A986-AC85E9AAEC22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jpeg"/><Relationship Id="rId2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0" y="0"/>
            <a:ext cx="9144000" cy="685800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>
            <a:off x="2369160" y="152280"/>
            <a:ext cx="5246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ffff00"/>
                </a:solidFill>
                <a:latin typeface="Tahoma"/>
              </a:rPr>
              <a:t>Fig.A: Ethanol Treatment vs Culture Medium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1204560" y="6377040"/>
            <a:ext cx="2361600" cy="2764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1% Ethanol in culture mediu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1218600" y="6583320"/>
            <a:ext cx="1342080" cy="2764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Culture mediu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7" name="" descr=""/>
          <p:cNvPicPr/>
          <p:nvPr/>
        </p:nvPicPr>
        <p:blipFill>
          <a:blip r:embed="rId1"/>
          <a:stretch/>
        </p:blipFill>
        <p:spPr>
          <a:xfrm>
            <a:off x="0" y="0"/>
            <a:ext cx="9144000" cy="6858000"/>
          </a:xfrm>
          <a:prstGeom prst="rect">
            <a:avLst/>
          </a:prstGeom>
          <a:ln w="0">
            <a:noFill/>
          </a:ln>
        </p:spPr>
      </p:pic>
      <p:sp>
        <p:nvSpPr>
          <p:cNvPr id="48" name=""/>
          <p:cNvSpPr/>
          <p:nvPr/>
        </p:nvSpPr>
        <p:spPr>
          <a:xfrm>
            <a:off x="2418120" y="152280"/>
            <a:ext cx="4956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ffff00"/>
                </a:solidFill>
                <a:latin typeface="Tahoma"/>
              </a:rPr>
              <a:t>Fig.B: TXL/PA Treatment vs PA Treatment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3581280" y="3886200"/>
            <a:ext cx="381240" cy="152280"/>
          </a:xfrm>
          <a:prstGeom prst="rect">
            <a:avLst/>
          </a:prstGeom>
          <a:noFill/>
          <a:ln w="9360">
            <a:solidFill>
              <a:srgbClr val="ffff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3642480" y="3516480"/>
            <a:ext cx="478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ffff"/>
                </a:solidFill>
                <a:latin typeface="Arial"/>
              </a:rPr>
              <a:t>p5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977760" y="5207040"/>
            <a:ext cx="381240" cy="152280"/>
          </a:xfrm>
          <a:prstGeom prst="rect">
            <a:avLst/>
          </a:prstGeom>
          <a:noFill/>
          <a:ln w="9360">
            <a:solidFill>
              <a:srgbClr val="ffff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992520" y="4952880"/>
            <a:ext cx="685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ffff"/>
                </a:solidFill>
                <a:latin typeface="Arial"/>
              </a:rPr>
              <a:t>AMPK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1193040" y="6373800"/>
            <a:ext cx="4292640" cy="2764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TXL (100 </a:t>
            </a:r>
            <a:r>
              <a:rPr b="1" lang="en-US" sz="1200" spc="-1" strike="noStrike">
                <a:solidFill>
                  <a:srgbClr val="ffffff"/>
                </a:solidFill>
                <a:latin typeface="Symbol"/>
                <a:ea typeface="Symbol"/>
              </a:rPr>
              <a:t></a:t>
            </a: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g/ml) preconditioning + PA (0.3 mM) treatmen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1180800" y="6603840"/>
            <a:ext cx="1791720" cy="2764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PA (0.3 mM) treatmen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11-02T12:27:54Z</dcterms:created>
  <dc:creator>wang</dc:creator>
  <dc:description/>
  <dc:language>en-US</dc:language>
  <cp:lastModifiedBy>wang</cp:lastModifiedBy>
  <dcterms:modified xsi:type="dcterms:W3CDTF">2008-04-20T00:33:56Z</dcterms:modified>
  <cp:revision>5</cp:revision>
  <dc:subject/>
  <dc:title>Slide 1</dc:title>
</cp:coreProperties>
</file>